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jpeg" ContentType="image/jpeg"/>
  <Override PartName="/ppt/media/image2.jpeg" ContentType="image/jpeg"/>
  <Override PartName="/ppt/media/image3.jpeg" ContentType="image/jpeg"/>
  <Override PartName="/ppt/media/image4.jpeg" ContentType="image/jpeg"/>
  <Override PartName="/ppt/media/image5.jpeg" ContentType="image/jpeg"/>
  <Override PartName="/ppt/media/image6.jpeg" ContentType="image/jpeg"/>
  <Override PartName="/ppt/media/image7.jpeg" ContentType="image/jpeg"/>
  <Override PartName="/ppt/media/image8.jpeg" ContentType="image/jpeg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4.xml.rels" ContentType="application/vnd.openxmlformats-package.relationships+xml"/>
  <Override PartName="/ppt/slides/_rels/slide1.xml.rels" ContentType="application/vnd.openxmlformats-package.relationships+xml"/>
  <Override PartName="/ppt/slides/_rels/slide3.xml.rels" ContentType="application/vnd.openxmlformats-package.relationships+xml"/>
  <Override PartName="/ppt/slides/_rels/slide2.xml.rels" ContentType="application/vnd.openxmlformats-package.relationships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  <p:sldId id="258" r:id="rId5"/>
    <p:sldId id="259" r:id="rId6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slide" Target="slides/slide3.xml"/><Relationship Id="rId6" Type="http://schemas.openxmlformats.org/officeDocument/2006/relationships/slide" Target="slides/slide4.xml"/><Relationship Id="rId7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7E2982A-7F3F-4975-ABDF-B1C6AC580507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4984EDB-6803-436E-9D3A-20230F0519ED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1FDC2B0-0E1F-4C36-AA5A-9CB37E0F05F7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B7A85C7-A3DE-4FA1-8224-6464A831A6FC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B568C0E-0E43-4086-87F0-5AD87F2D4EE2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B960ACB-2EB1-4E54-BF7B-F927F8172780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AAEE304-8E33-434F-B3B5-545D1E87B4B7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D163CF6-4E85-4BE3-8CCA-47D1D14B2F5C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4D91D54-46DC-4729-BAE3-6E42FC17A35E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82F26D1-991F-4C26-A640-EE1E7F6B0AD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262B89D-3AA9-4087-BFED-1737F871C21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9C4E6A6-A743-45FC-9B66-46C528A16B4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880A4C29-2D55-46C5-B4EC-0A7A566BB79B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image" Target="../media/image2.jpeg"/><Relationship Id="rId3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3.jpeg"/><Relationship Id="rId2" Type="http://schemas.openxmlformats.org/officeDocument/2006/relationships/image" Target="../media/image4.jpeg"/><Relationship Id="rId3" Type="http://schemas.openxmlformats.org/officeDocument/2006/relationships/slideLayout" Target="../slideLayouts/slideLayout1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image" Target="../media/image5.jpeg"/><Relationship Id="rId2" Type="http://schemas.openxmlformats.org/officeDocument/2006/relationships/image" Target="../media/image6.jpeg"/><Relationship Id="rId3" Type="http://schemas.openxmlformats.org/officeDocument/2006/relationships/slideLayout" Target="../slideLayouts/slideLayout1.xml"/>
</Relationships>
</file>

<file path=ppt/slides/_rels/slide4.xml.rels><?xml version="1.0" encoding="UTF-8"?>
<Relationships xmlns="http://schemas.openxmlformats.org/package/2006/relationships"><Relationship Id="rId1" Type="http://schemas.openxmlformats.org/officeDocument/2006/relationships/image" Target="../media/image7.jpeg"/><Relationship Id="rId2" Type="http://schemas.openxmlformats.org/officeDocument/2006/relationships/image" Target="../media/image8.jpeg"/><Relationship Id="rId3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1" name=""/>
          <p:cNvGraphicFramePr/>
          <p:nvPr/>
        </p:nvGraphicFramePr>
        <p:xfrm>
          <a:off x="395280" y="3573360"/>
          <a:ext cx="4176720" cy="1701720"/>
        </p:xfrm>
        <a:graphic>
          <a:graphicData uri="http://schemas.openxmlformats.org/drawingml/2006/table">
            <a:tbl>
              <a:tblPr/>
              <a:tblGrid>
                <a:gridCol w="528840"/>
                <a:gridCol w="612720"/>
                <a:gridCol w="614160"/>
                <a:gridCol w="613080"/>
                <a:gridCol w="603000"/>
                <a:gridCol w="601920"/>
                <a:gridCol w="603000"/>
              </a:tblGrid>
              <a:tr h="212760"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40m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60m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80m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h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4h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6h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12760"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0m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03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001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0004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.87E-06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8.39E-09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.82E-07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12400"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40m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12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006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6.56E-07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3.96E-15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6.03E-1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12760"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60m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11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.54E-05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.23E-16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8.28E-09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12760"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80m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.87E-02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.20E-1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.45E-04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12760"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h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3.09E-06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.80E-01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12760"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4h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.38E-05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12760"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6h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</a:tbl>
          </a:graphicData>
        </a:graphic>
      </p:graphicFrame>
      <p:sp>
        <p:nvSpPr>
          <p:cNvPr id="42" name=""/>
          <p:cNvSpPr/>
          <p:nvPr/>
        </p:nvSpPr>
        <p:spPr>
          <a:xfrm>
            <a:off x="1187280" y="189000"/>
            <a:ext cx="27370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LPS – Gene Induction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3" name="" descr=""/>
          <p:cNvPicPr/>
          <p:nvPr/>
        </p:nvPicPr>
        <p:blipFill>
          <a:blip r:embed="rId1"/>
          <a:srcRect l="0" t="9417" r="3139" b="7297"/>
          <a:stretch/>
        </p:blipFill>
        <p:spPr>
          <a:xfrm>
            <a:off x="468360" y="549360"/>
            <a:ext cx="3816360" cy="2717640"/>
          </a:xfrm>
          <a:prstGeom prst="rect">
            <a:avLst/>
          </a:prstGeom>
          <a:ln w="0">
            <a:noFill/>
          </a:ln>
        </p:spPr>
      </p:pic>
      <p:grpSp>
        <p:nvGrpSpPr>
          <p:cNvPr id="44" name=""/>
          <p:cNvGrpSpPr/>
          <p:nvPr/>
        </p:nvGrpSpPr>
        <p:grpSpPr>
          <a:xfrm>
            <a:off x="5003640" y="243000"/>
            <a:ext cx="3672000" cy="3185640"/>
            <a:chOff x="5003640" y="243000"/>
            <a:chExt cx="3672000" cy="3185640"/>
          </a:xfrm>
        </p:grpSpPr>
        <p:pic>
          <p:nvPicPr>
            <p:cNvPr id="45" name="" descr=""/>
            <p:cNvPicPr/>
            <p:nvPr/>
          </p:nvPicPr>
          <p:blipFill>
            <a:blip r:embed="rId2"/>
            <a:srcRect l="0" t="8905" r="0" b="6528"/>
            <a:stretch/>
          </p:blipFill>
          <p:spPr>
            <a:xfrm>
              <a:off x="5003640" y="449280"/>
              <a:ext cx="3529080" cy="297936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46" name=""/>
            <p:cNvSpPr/>
            <p:nvPr/>
          </p:nvSpPr>
          <p:spPr>
            <a:xfrm>
              <a:off x="5795640" y="243000"/>
              <a:ext cx="288000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876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</a:rPr>
                <a:t>TNF - Gene Induction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aphicFrame>
        <p:nvGraphicFramePr>
          <p:cNvPr id="47" name=""/>
          <p:cNvGraphicFramePr/>
          <p:nvPr/>
        </p:nvGraphicFramePr>
        <p:xfrm>
          <a:off x="5940360" y="3645000"/>
          <a:ext cx="2000160" cy="733320"/>
        </p:xfrm>
        <a:graphic>
          <a:graphicData uri="http://schemas.openxmlformats.org/drawingml/2006/table">
            <a:tbl>
              <a:tblPr/>
              <a:tblGrid>
                <a:gridCol w="609840"/>
                <a:gridCol w="695160"/>
                <a:gridCol w="695160"/>
              </a:tblGrid>
              <a:tr h="246240"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h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2h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46240"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30m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.34E-05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.03E-1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46240"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h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7.24E-07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</a:tbl>
          </a:graphicData>
        </a:graphic>
      </p:graphicFrame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8" name=""/>
          <p:cNvGrpSpPr/>
          <p:nvPr/>
        </p:nvGrpSpPr>
        <p:grpSpPr>
          <a:xfrm>
            <a:off x="611280" y="260280"/>
            <a:ext cx="3887280" cy="3147840"/>
            <a:chOff x="611280" y="260280"/>
            <a:chExt cx="3887280" cy="3147840"/>
          </a:xfrm>
        </p:grpSpPr>
        <p:pic>
          <p:nvPicPr>
            <p:cNvPr id="49" name="" descr=""/>
            <p:cNvPicPr/>
            <p:nvPr/>
          </p:nvPicPr>
          <p:blipFill>
            <a:blip r:embed="rId1"/>
            <a:srcRect l="0" t="9919" r="0" b="6855"/>
            <a:stretch/>
          </p:blipFill>
          <p:spPr>
            <a:xfrm>
              <a:off x="611280" y="476280"/>
              <a:ext cx="3528720" cy="293184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50" name=""/>
            <p:cNvSpPr/>
            <p:nvPr/>
          </p:nvSpPr>
          <p:spPr>
            <a:xfrm>
              <a:off x="1042920" y="260280"/>
              <a:ext cx="345564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spcBef>
                  <a:spcPts val="876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</a:rPr>
                <a:t>IFN gamma - Gene Induction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51" name=""/>
          <p:cNvGrpSpPr/>
          <p:nvPr/>
        </p:nvGrpSpPr>
        <p:grpSpPr>
          <a:xfrm>
            <a:off x="4500720" y="189000"/>
            <a:ext cx="4032000" cy="3255480"/>
            <a:chOff x="4500720" y="189000"/>
            <a:chExt cx="4032000" cy="3255480"/>
          </a:xfrm>
        </p:grpSpPr>
        <p:pic>
          <p:nvPicPr>
            <p:cNvPr id="52" name="" descr=""/>
            <p:cNvPicPr/>
            <p:nvPr/>
          </p:nvPicPr>
          <p:blipFill>
            <a:blip r:embed="rId2"/>
            <a:srcRect l="0" t="8923" r="0" b="6340"/>
            <a:stretch/>
          </p:blipFill>
          <p:spPr>
            <a:xfrm>
              <a:off x="4500720" y="411120"/>
              <a:ext cx="4032000" cy="303336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53" name=""/>
            <p:cNvSpPr/>
            <p:nvPr/>
          </p:nvSpPr>
          <p:spPr>
            <a:xfrm>
              <a:off x="5365800" y="189000"/>
              <a:ext cx="295056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spcBef>
                  <a:spcPts val="876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</a:rPr>
                <a:t>PDGF - Gene Induction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aphicFrame>
        <p:nvGraphicFramePr>
          <p:cNvPr id="54" name=""/>
          <p:cNvGraphicFramePr/>
          <p:nvPr/>
        </p:nvGraphicFramePr>
        <p:xfrm>
          <a:off x="1116000" y="3716280"/>
          <a:ext cx="2708280" cy="977760"/>
        </p:xfrm>
        <a:graphic>
          <a:graphicData uri="http://schemas.openxmlformats.org/drawingml/2006/table">
            <a:tbl>
              <a:tblPr/>
              <a:tblGrid>
                <a:gridCol w="609480"/>
                <a:gridCol w="708120"/>
                <a:gridCol w="695520"/>
                <a:gridCol w="695160"/>
              </a:tblGrid>
              <a:tr h="246240"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h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4h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8h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46240"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h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018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.56E-07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.31E-09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46240"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h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5.44E-04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.25E-07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46240"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4h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.14E-05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</a:tbl>
          </a:graphicData>
        </a:graphic>
      </p:graphicFrame>
      <p:graphicFrame>
        <p:nvGraphicFramePr>
          <p:cNvPr id="55" name=""/>
          <p:cNvGraphicFramePr/>
          <p:nvPr/>
        </p:nvGraphicFramePr>
        <p:xfrm>
          <a:off x="4572000" y="3716280"/>
          <a:ext cx="4086360" cy="1467000"/>
        </p:xfrm>
        <a:graphic>
          <a:graphicData uri="http://schemas.openxmlformats.org/drawingml/2006/table">
            <a:tbl>
              <a:tblPr/>
              <a:tblGrid>
                <a:gridCol w="609480"/>
                <a:gridCol w="695520"/>
                <a:gridCol w="695160"/>
                <a:gridCol w="695520"/>
                <a:gridCol w="695160"/>
                <a:gridCol w="695520"/>
              </a:tblGrid>
              <a:tr h="246240"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h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h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3h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4h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8h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46240"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30m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5.96E-08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3.90E-2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.02E-28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.38E-3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5.75E-35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46240"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h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.91E-1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3.46E-3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6.37E-36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7.44E-5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46240"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h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5.93E-19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.10E-23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.26E-48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46240"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3h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7.93E-0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.64E-1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46240"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4h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6.59E-1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</a:tbl>
          </a:graphicData>
        </a:graphic>
      </p:graphicFrame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6" name=""/>
          <p:cNvGrpSpPr/>
          <p:nvPr/>
        </p:nvGrpSpPr>
        <p:grpSpPr>
          <a:xfrm>
            <a:off x="828720" y="115920"/>
            <a:ext cx="3311640" cy="3022560"/>
            <a:chOff x="828720" y="115920"/>
            <a:chExt cx="3311640" cy="3022560"/>
          </a:xfrm>
        </p:grpSpPr>
        <p:pic>
          <p:nvPicPr>
            <p:cNvPr id="57" name="" descr=""/>
            <p:cNvPicPr/>
            <p:nvPr/>
          </p:nvPicPr>
          <p:blipFill>
            <a:blip r:embed="rId1"/>
            <a:srcRect l="0" t="8342" r="0" b="6838"/>
            <a:stretch/>
          </p:blipFill>
          <p:spPr>
            <a:xfrm>
              <a:off x="828720" y="333360"/>
              <a:ext cx="3311640" cy="280512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58" name=""/>
            <p:cNvSpPr/>
            <p:nvPr/>
          </p:nvSpPr>
          <p:spPr>
            <a:xfrm>
              <a:off x="1116000" y="115920"/>
              <a:ext cx="295128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spcBef>
                  <a:spcPts val="876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</a:rPr>
                <a:t>BPA - Gene Induction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59" name=""/>
          <p:cNvGrpSpPr/>
          <p:nvPr/>
        </p:nvGrpSpPr>
        <p:grpSpPr>
          <a:xfrm>
            <a:off x="4645080" y="115920"/>
            <a:ext cx="3456000" cy="3057480"/>
            <a:chOff x="4645080" y="115920"/>
            <a:chExt cx="3456000" cy="3057480"/>
          </a:xfrm>
        </p:grpSpPr>
        <p:pic>
          <p:nvPicPr>
            <p:cNvPr id="60" name="" descr=""/>
            <p:cNvPicPr/>
            <p:nvPr/>
          </p:nvPicPr>
          <p:blipFill>
            <a:blip r:embed="rId2"/>
            <a:srcRect l="0" t="9705" r="2222" b="6680"/>
            <a:stretch/>
          </p:blipFill>
          <p:spPr>
            <a:xfrm>
              <a:off x="4716720" y="404640"/>
              <a:ext cx="3241440" cy="276876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61" name=""/>
            <p:cNvSpPr/>
            <p:nvPr/>
          </p:nvSpPr>
          <p:spPr>
            <a:xfrm>
              <a:off x="4645080" y="115920"/>
              <a:ext cx="345600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spcBef>
                  <a:spcPts val="876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</a:rPr>
                <a:t>Anisomycin - Gene Induction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aphicFrame>
        <p:nvGraphicFramePr>
          <p:cNvPr id="62" name=""/>
          <p:cNvGraphicFramePr/>
          <p:nvPr/>
        </p:nvGraphicFramePr>
        <p:xfrm>
          <a:off x="1476360" y="3500280"/>
          <a:ext cx="2000160" cy="733680"/>
        </p:xfrm>
        <a:graphic>
          <a:graphicData uri="http://schemas.openxmlformats.org/drawingml/2006/table">
            <a:tbl>
              <a:tblPr/>
              <a:tblGrid>
                <a:gridCol w="609480"/>
                <a:gridCol w="695520"/>
                <a:gridCol w="695160"/>
              </a:tblGrid>
              <a:tr h="246240"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6h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2h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46240"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3h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7.38E-18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.07E-36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46240"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6h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.91E-08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</a:tbl>
          </a:graphicData>
        </a:graphic>
      </p:graphicFrame>
      <p:graphicFrame>
        <p:nvGraphicFramePr>
          <p:cNvPr id="63" name=""/>
          <p:cNvGraphicFramePr/>
          <p:nvPr/>
        </p:nvGraphicFramePr>
        <p:xfrm>
          <a:off x="4932360" y="3500280"/>
          <a:ext cx="2720880" cy="977760"/>
        </p:xfrm>
        <a:graphic>
          <a:graphicData uri="http://schemas.openxmlformats.org/drawingml/2006/table">
            <a:tbl>
              <a:tblPr/>
              <a:tblGrid>
                <a:gridCol w="609480"/>
                <a:gridCol w="708120"/>
                <a:gridCol w="708120"/>
                <a:gridCol w="695160"/>
              </a:tblGrid>
              <a:tr h="246240"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h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3h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6h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46240"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h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2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0004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.61E-06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46240"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h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00018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3.38E-1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46240"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3h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.77E-04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</a:tbl>
          </a:graphicData>
        </a:graphic>
      </p:graphicFrame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64" name=""/>
          <p:cNvGrpSpPr/>
          <p:nvPr/>
        </p:nvGrpSpPr>
        <p:grpSpPr>
          <a:xfrm>
            <a:off x="684360" y="260280"/>
            <a:ext cx="3456000" cy="3102120"/>
            <a:chOff x="684360" y="260280"/>
            <a:chExt cx="3456000" cy="3102120"/>
          </a:xfrm>
        </p:grpSpPr>
        <p:pic>
          <p:nvPicPr>
            <p:cNvPr id="65" name="" descr=""/>
            <p:cNvPicPr/>
            <p:nvPr/>
          </p:nvPicPr>
          <p:blipFill>
            <a:blip r:embed="rId1"/>
            <a:srcRect l="0" t="8652" r="0" b="6111"/>
            <a:stretch/>
          </p:blipFill>
          <p:spPr>
            <a:xfrm>
              <a:off x="684360" y="482400"/>
              <a:ext cx="3384720" cy="288000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66" name=""/>
            <p:cNvSpPr/>
            <p:nvPr/>
          </p:nvSpPr>
          <p:spPr>
            <a:xfrm>
              <a:off x="829080" y="260280"/>
              <a:ext cx="331128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spcBef>
                  <a:spcPts val="876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</a:rPr>
                <a:t>Asbestos - Gene Induction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67" name=""/>
          <p:cNvGrpSpPr/>
          <p:nvPr/>
        </p:nvGrpSpPr>
        <p:grpSpPr>
          <a:xfrm>
            <a:off x="4500720" y="206280"/>
            <a:ext cx="3527280" cy="3222720"/>
            <a:chOff x="4500720" y="206280"/>
            <a:chExt cx="3527280" cy="3222720"/>
          </a:xfrm>
        </p:grpSpPr>
        <p:pic>
          <p:nvPicPr>
            <p:cNvPr id="68" name="" descr=""/>
            <p:cNvPicPr/>
            <p:nvPr/>
          </p:nvPicPr>
          <p:blipFill>
            <a:blip r:embed="rId2"/>
            <a:srcRect l="0" t="9209" r="0" b="5610"/>
            <a:stretch/>
          </p:blipFill>
          <p:spPr>
            <a:xfrm>
              <a:off x="4500720" y="428400"/>
              <a:ext cx="3527280" cy="300060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69" name=""/>
            <p:cNvSpPr/>
            <p:nvPr/>
          </p:nvSpPr>
          <p:spPr>
            <a:xfrm>
              <a:off x="4932360" y="206280"/>
              <a:ext cx="302436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spcBef>
                  <a:spcPts val="876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</a:rPr>
                <a:t>Serum - Gene Induction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aphicFrame>
        <p:nvGraphicFramePr>
          <p:cNvPr id="70" name=""/>
          <p:cNvGraphicFramePr/>
          <p:nvPr/>
        </p:nvGraphicFramePr>
        <p:xfrm>
          <a:off x="1763640" y="3789360"/>
          <a:ext cx="1305000" cy="488880"/>
        </p:xfrm>
        <a:graphic>
          <a:graphicData uri="http://schemas.openxmlformats.org/drawingml/2006/table">
            <a:tbl>
              <a:tblPr/>
              <a:tblGrid>
                <a:gridCol w="609480"/>
                <a:gridCol w="695520"/>
              </a:tblGrid>
              <a:tr h="246240"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6h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46240"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h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7.58E-05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</a:tbl>
          </a:graphicData>
        </a:graphic>
      </p:graphicFrame>
      <p:graphicFrame>
        <p:nvGraphicFramePr>
          <p:cNvPr id="71" name=""/>
          <p:cNvGraphicFramePr/>
          <p:nvPr/>
        </p:nvGraphicFramePr>
        <p:xfrm>
          <a:off x="5076720" y="3716280"/>
          <a:ext cx="2610000" cy="977760"/>
        </p:xfrm>
        <a:graphic>
          <a:graphicData uri="http://schemas.openxmlformats.org/drawingml/2006/table">
            <a:tbl>
              <a:tblPr/>
              <a:tblGrid>
                <a:gridCol w="609480"/>
                <a:gridCol w="609840"/>
                <a:gridCol w="695160"/>
                <a:gridCol w="695520"/>
              </a:tblGrid>
              <a:tr h="246240"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4h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6h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8h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46240"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h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0028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5.67E-07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4.56E-1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46240"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4h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9.25E-03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.91E-06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46240"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6h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algn="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4.72E-03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</a:tbl>
          </a:graphicData>
        </a:graphic>
      </p:graphicFrame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482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9-07-26T12:10:21Z</dcterms:created>
  <dc:creator>user</dc:creator>
  <dc:description/>
  <dc:language>en-US</dc:language>
  <cp:lastModifiedBy>user</cp:lastModifiedBy>
  <dcterms:modified xsi:type="dcterms:W3CDTF">2010-04-15T10:52:16Z</dcterms:modified>
  <cp:revision>84</cp:revision>
  <dc:subject/>
  <dc:title>Slide 1</dc:title>
</cp:coreProperties>
</file>